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0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33FF"/>
    <a:srgbClr val="800000"/>
    <a:srgbClr val="FF33CC"/>
    <a:srgbClr val="3124DC"/>
    <a:srgbClr val="0066FF"/>
    <a:srgbClr val="00FF00"/>
    <a:srgbClr val="0000FF"/>
    <a:srgbClr val="D99694"/>
    <a:srgbClr val="953735"/>
    <a:srgbClr val="FFFF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886" autoAdjust="0"/>
  </p:normalViewPr>
  <p:slideViewPr>
    <p:cSldViewPr>
      <p:cViewPr>
        <p:scale>
          <a:sx n="110" d="100"/>
          <a:sy n="110" d="100"/>
        </p:scale>
        <p:origin x="-2586" y="13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COMP0850\steeg002$\001.STW_3%20final%20version\Correlation\500vs16%20IQR%20correlatie\500vs16%20IQR%20matri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952826456522448E-2"/>
          <c:y val="5.5555555555555552E-2"/>
          <c:w val="0.92047173543477556"/>
          <c:h val="0.4932469378827646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All genes_vs_Bact'!$Y$3</c:f>
              <c:strCache>
                <c:ptCount val="1"/>
                <c:pt idx="0">
                  <c:v>R&lt;-0.75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multiLvlStrRef>
              <c:f>'All genes_vs_Bact'!$Z$1:$AO$2</c:f>
              <c:multiLvlStrCache>
                <c:ptCount val="16"/>
                <c:lvl>
                  <c:pt idx="0">
                    <c:v>Rikenellaceae</c:v>
                  </c:pt>
                  <c:pt idx="1">
                    <c:v>Bacteroidaceae</c:v>
                  </c:pt>
                  <c:pt idx="2">
                    <c:v>Porphyromonadaceae</c:v>
                  </c:pt>
                  <c:pt idx="3">
                    <c:v>Lachnospiraceae</c:v>
                  </c:pt>
                  <c:pt idx="4">
                    <c:v>Ruminococcaceae</c:v>
                  </c:pt>
                  <c:pt idx="5">
                    <c:v>Streptococcaceae</c:v>
                  </c:pt>
                  <c:pt idx="6">
                    <c:v>Lactobacillaceae</c:v>
                  </c:pt>
                  <c:pt idx="7">
                    <c:v>Enterococcaceae</c:v>
                  </c:pt>
                  <c:pt idx="8">
                    <c:v>Erysipelotrichaceae</c:v>
                  </c:pt>
                  <c:pt idx="9">
                    <c:v>Micrococcineae</c:v>
                  </c:pt>
                  <c:pt idx="10">
                    <c:v>Corynebacterineae</c:v>
                  </c:pt>
                  <c:pt idx="11">
                    <c:v>Coriobacterineae</c:v>
                  </c:pt>
                  <c:pt idx="12">
                    <c:v>Pasteurellaceae</c:v>
                  </c:pt>
                  <c:pt idx="13">
                    <c:v>Enterobacteriaceae</c:v>
                  </c:pt>
                  <c:pt idx="14">
                    <c:v>Anaeroplasmataceae</c:v>
                  </c:pt>
                  <c:pt idx="15">
                    <c:v>Verrucomicrobiaceae</c:v>
                  </c:pt>
                </c:lvl>
                <c:lvl>
                  <c:pt idx="0">
                    <c:v>Bacteroidetes</c:v>
                  </c:pt>
                  <c:pt idx="3">
                    <c:v>Firmicutes</c:v>
                  </c:pt>
                  <c:pt idx="9">
                    <c:v>Actinobacteria</c:v>
                  </c:pt>
                  <c:pt idx="12">
                    <c:v>Prot.</c:v>
                  </c:pt>
                  <c:pt idx="14">
                    <c:v>Ten.</c:v>
                  </c:pt>
                  <c:pt idx="15">
                    <c:v>Verr.</c:v>
                  </c:pt>
                </c:lvl>
              </c:multiLvlStrCache>
            </c:multiLvlStrRef>
          </c:cat>
          <c:val>
            <c:numRef>
              <c:f>'All genes_vs_Bact'!$Z$3:$AO$3</c:f>
              <c:numCache>
                <c:formatCode>General</c:formatCode>
                <c:ptCount val="16"/>
                <c:pt idx="0">
                  <c:v>3</c:v>
                </c:pt>
                <c:pt idx="1">
                  <c:v>129</c:v>
                </c:pt>
                <c:pt idx="2">
                  <c:v>13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4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</c:ser>
        <c:ser>
          <c:idx val="1"/>
          <c:order val="1"/>
          <c:tx>
            <c:strRef>
              <c:f>'All genes_vs_Bact'!$Y$4</c:f>
              <c:strCache>
                <c:ptCount val="1"/>
                <c:pt idx="0">
                  <c:v>R&gt;0.75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multiLvlStrRef>
              <c:f>'All genes_vs_Bact'!$Z$1:$AO$2</c:f>
              <c:multiLvlStrCache>
                <c:ptCount val="16"/>
                <c:lvl>
                  <c:pt idx="0">
                    <c:v>Rikenellaceae</c:v>
                  </c:pt>
                  <c:pt idx="1">
                    <c:v>Bacteroidaceae</c:v>
                  </c:pt>
                  <c:pt idx="2">
                    <c:v>Porphyromonadaceae</c:v>
                  </c:pt>
                  <c:pt idx="3">
                    <c:v>Lachnospiraceae</c:v>
                  </c:pt>
                  <c:pt idx="4">
                    <c:v>Ruminococcaceae</c:v>
                  </c:pt>
                  <c:pt idx="5">
                    <c:v>Streptococcaceae</c:v>
                  </c:pt>
                  <c:pt idx="6">
                    <c:v>Lactobacillaceae</c:v>
                  </c:pt>
                  <c:pt idx="7">
                    <c:v>Enterococcaceae</c:v>
                  </c:pt>
                  <c:pt idx="8">
                    <c:v>Erysipelotrichaceae</c:v>
                  </c:pt>
                  <c:pt idx="9">
                    <c:v>Micrococcineae</c:v>
                  </c:pt>
                  <c:pt idx="10">
                    <c:v>Corynebacterineae</c:v>
                  </c:pt>
                  <c:pt idx="11">
                    <c:v>Coriobacterineae</c:v>
                  </c:pt>
                  <c:pt idx="12">
                    <c:v>Pasteurellaceae</c:v>
                  </c:pt>
                  <c:pt idx="13">
                    <c:v>Enterobacteriaceae</c:v>
                  </c:pt>
                  <c:pt idx="14">
                    <c:v>Anaeroplasmataceae</c:v>
                  </c:pt>
                  <c:pt idx="15">
                    <c:v>Verrucomicrobiaceae</c:v>
                  </c:pt>
                </c:lvl>
                <c:lvl>
                  <c:pt idx="0">
                    <c:v>Bacteroidetes</c:v>
                  </c:pt>
                  <c:pt idx="3">
                    <c:v>Firmicutes</c:v>
                  </c:pt>
                  <c:pt idx="9">
                    <c:v>Actinobacteria</c:v>
                  </c:pt>
                  <c:pt idx="12">
                    <c:v>Prot.</c:v>
                  </c:pt>
                  <c:pt idx="14">
                    <c:v>Ten.</c:v>
                  </c:pt>
                  <c:pt idx="15">
                    <c:v>Verr.</c:v>
                  </c:pt>
                </c:lvl>
              </c:multiLvlStrCache>
            </c:multiLvlStrRef>
          </c:cat>
          <c:val>
            <c:numRef>
              <c:f>'All genes_vs_Bact'!$Z$4:$AO$4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3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3443584"/>
        <c:axId val="137461760"/>
      </c:barChart>
      <c:catAx>
        <c:axId val="133443584"/>
        <c:scaling>
          <c:orientation val="minMax"/>
        </c:scaling>
        <c:delete val="0"/>
        <c:axPos val="b"/>
        <c:majorTickMark val="out"/>
        <c:minorTickMark val="none"/>
        <c:tickLblPos val="nextTo"/>
        <c:crossAx val="137461760"/>
        <c:crosses val="autoZero"/>
        <c:auto val="1"/>
        <c:lblAlgn val="ctr"/>
        <c:lblOffset val="100"/>
        <c:noMultiLvlLbl val="0"/>
      </c:catAx>
      <c:valAx>
        <c:axId val="1374617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/>
                  <a:t># </a:t>
                </a:r>
                <a:r>
                  <a:rPr lang="en-US" b="0" dirty="0" smtClean="0"/>
                  <a:t>Genes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334435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5164260717410323"/>
          <c:y val="1.0799431321084843E-2"/>
          <c:w val="0.34557961504811896"/>
          <c:h val="8.9512248468941374E-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12CB26-4510-413A-82B2-624CBA73BA67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42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242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F225DB-C04D-46D0-BD80-23992DE3AA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08172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8E0A08-3BAE-41ED-82C3-9CD964C4F256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5710"/>
            <a:ext cx="5438775" cy="44665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42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242"/>
            <a:ext cx="2946400" cy="49680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13DDBE-9BA8-42BF-95F2-8C36EDDD2E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225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864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6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631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12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79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8782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978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7324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6890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4229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850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1FC8C-8076-474B-912A-24C31F53ECFE}" type="datetimeFigureOut">
              <a:rPr lang="en-GB" smtClean="0"/>
              <a:t>25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5451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1343" y="128586"/>
            <a:ext cx="284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1S: related to figure 5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684999" y="53026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grpSp>
        <p:nvGrpSpPr>
          <p:cNvPr id="27" name="Group 26"/>
          <p:cNvGrpSpPr/>
          <p:nvPr/>
        </p:nvGrpSpPr>
        <p:grpSpPr>
          <a:xfrm>
            <a:off x="260648" y="899595"/>
            <a:ext cx="5112568" cy="4068467"/>
            <a:chOff x="260648" y="899595"/>
            <a:chExt cx="5112568" cy="4068467"/>
          </a:xfrm>
        </p:grpSpPr>
        <p:grpSp>
          <p:nvGrpSpPr>
            <p:cNvPr id="7" name="Group 6"/>
            <p:cNvGrpSpPr/>
            <p:nvPr/>
          </p:nvGrpSpPr>
          <p:grpSpPr>
            <a:xfrm>
              <a:off x="260648" y="899595"/>
              <a:ext cx="5074198" cy="4068467"/>
              <a:chOff x="260648" y="899592"/>
              <a:chExt cx="5074198" cy="5201468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0648" y="899592"/>
                <a:ext cx="5074198" cy="50956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Rectangle 4"/>
              <p:cNvSpPr/>
              <p:nvPr/>
            </p:nvSpPr>
            <p:spPr>
              <a:xfrm>
                <a:off x="260648" y="5976156"/>
                <a:ext cx="5074198" cy="1249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6" name="Rectangle 25"/>
            <p:cNvSpPr/>
            <p:nvPr/>
          </p:nvSpPr>
          <p:spPr>
            <a:xfrm>
              <a:off x="4725144" y="1691680"/>
              <a:ext cx="648072" cy="273630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4617132" y="1656256"/>
            <a:ext cx="3330576" cy="2843188"/>
            <a:chOff x="4617132" y="1656256"/>
            <a:chExt cx="3330576" cy="2843188"/>
          </a:xfrm>
        </p:grpSpPr>
        <p:sp>
          <p:nvSpPr>
            <p:cNvPr id="10" name="Rectangle 9"/>
            <p:cNvSpPr/>
            <p:nvPr/>
          </p:nvSpPr>
          <p:spPr>
            <a:xfrm>
              <a:off x="4617132" y="2181577"/>
              <a:ext cx="3119692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Lachnospir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617132" y="2358000"/>
              <a:ext cx="2176685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Ruminococc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617132" y="1656256"/>
              <a:ext cx="248832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Anaeroplasmat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617132" y="2005200"/>
              <a:ext cx="242532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800" dirty="0" smtClean="0">
                  <a:solidFill>
                    <a:prstClr val="black"/>
                  </a:solidFill>
                </a:rPr>
                <a:t>Lactobacillaceae</a:t>
              </a:r>
              <a:endParaRPr lang="en-GB" dirty="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4617132" y="1832400"/>
              <a:ext cx="255227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800" dirty="0" smtClean="0">
                  <a:solidFill>
                    <a:prstClr val="black"/>
                  </a:solidFill>
                </a:rPr>
                <a:t>Pasteurellaceae</a:t>
              </a:r>
              <a:endParaRPr lang="en-GB" dirty="0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617132" y="2707200"/>
              <a:ext cx="2421855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Streptococc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4617132" y="2530800"/>
              <a:ext cx="2246201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Corynebacterin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4617132" y="2883600"/>
              <a:ext cx="2145630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Enterococc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4617132" y="3056400"/>
              <a:ext cx="2440564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Enterobacteri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617132" y="3232800"/>
              <a:ext cx="2145085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Coriobacterin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617132" y="3758400"/>
              <a:ext cx="272805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Erysipelotrich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4617132" y="3934800"/>
              <a:ext cx="265064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800" dirty="0" smtClean="0">
                  <a:solidFill>
                    <a:prstClr val="black"/>
                  </a:solidFill>
                </a:rPr>
                <a:t>Micrococcineae</a:t>
              </a:r>
              <a:endParaRPr lang="en-GB" dirty="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4617132" y="3409200"/>
              <a:ext cx="275794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Rikenell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4617132" y="3563888"/>
              <a:ext cx="240946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800" dirty="0" smtClean="0">
                  <a:solidFill>
                    <a:prstClr val="black"/>
                  </a:solidFill>
                </a:rPr>
                <a:t>Verrucomicrobiaceae</a:t>
              </a:r>
              <a:endParaRPr lang="en-GB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4617132" y="4284000"/>
              <a:ext cx="277129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Bacteroid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617132" y="4107600"/>
              <a:ext cx="3330576" cy="1941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GB" sz="800" dirty="0" smtClean="0">
                  <a:solidFill>
                    <a:prstClr val="black"/>
                  </a:solidFill>
                </a:rPr>
                <a:t>Porphyromonadaceae</a:t>
              </a:r>
              <a:endParaRPr lang="en-GB" sz="800" dirty="0">
                <a:solidFill>
                  <a:prstClr val="black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5437364" y="2970669"/>
              <a:ext cx="591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Microbiota</a:t>
              </a:r>
              <a:endParaRPr lang="en-GB" sz="800" b="1" dirty="0"/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 rot="16200000">
              <a:off x="5310540" y="2327974"/>
              <a:ext cx="85878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 rot="16200000" flipH="1">
              <a:off x="5312114" y="3755859"/>
              <a:ext cx="85878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TextBox 33"/>
          <p:cNvSpPr txBox="1"/>
          <p:nvPr/>
        </p:nvSpPr>
        <p:spPr>
          <a:xfrm>
            <a:off x="2816782" y="4546917"/>
            <a:ext cx="445956" cy="1941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/>
              <a:t>Genes</a:t>
            </a:r>
            <a:endParaRPr lang="en-GB" sz="800" b="1" dirty="0"/>
          </a:p>
        </p:txBody>
      </p:sp>
      <p:cxnSp>
        <p:nvCxnSpPr>
          <p:cNvPr id="35" name="Straight Arrow Connector 34"/>
          <p:cNvCxnSpPr>
            <a:stCxn id="34" idx="3"/>
          </p:cNvCxnSpPr>
          <p:nvPr/>
        </p:nvCxnSpPr>
        <p:spPr>
          <a:xfrm>
            <a:off x="3262738" y="4644007"/>
            <a:ext cx="1426402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flipH="1">
            <a:off x="1304764" y="4643634"/>
            <a:ext cx="151201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8" name="Rectangle 2047"/>
          <p:cNvSpPr/>
          <p:nvPr/>
        </p:nvSpPr>
        <p:spPr>
          <a:xfrm>
            <a:off x="2708920" y="4741096"/>
            <a:ext cx="648072" cy="1781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53" name="TextBox 2052"/>
          <p:cNvSpPr txBox="1"/>
          <p:nvPr/>
        </p:nvSpPr>
        <p:spPr>
          <a:xfrm>
            <a:off x="908721" y="7848364"/>
            <a:ext cx="52682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Supplemental Figure 1: </a:t>
            </a:r>
            <a:r>
              <a:rPr lang="en-GB" sz="800" dirty="0"/>
              <a:t>Integration of the 500 most variable genes with 16 MO families present with a relative abundance &gt;0.1% in the colonic luminal content of two-week-old mice.</a:t>
            </a:r>
            <a:r>
              <a:rPr lang="en-GB" sz="800" b="1" dirty="0"/>
              <a:t> (A) </a:t>
            </a:r>
            <a:r>
              <a:rPr lang="en-GB" sz="800" dirty="0"/>
              <a:t>A Clustered Image Map (CIM) demonstrates </a:t>
            </a:r>
            <a:r>
              <a:rPr lang="en-GB" sz="800" dirty="0" smtClean="0"/>
              <a:t>a </a:t>
            </a:r>
            <a:r>
              <a:rPr lang="en-GB" sz="800" dirty="0"/>
              <a:t>separation of both the 16 MO families and genes into two </a:t>
            </a:r>
            <a:r>
              <a:rPr lang="en-GB" sz="800" dirty="0" smtClean="0"/>
              <a:t>major clusters. </a:t>
            </a:r>
            <a:r>
              <a:rPr lang="en-GB" sz="800" b="1" dirty="0"/>
              <a:t>(B) </a:t>
            </a:r>
            <a:r>
              <a:rPr lang="en-GB" sz="800" dirty="0"/>
              <a:t>Quantification of the strong (R&lt;-0.75 or R&gt;0.75) correlation revealed that the strongest correlation was found for Bacteroidaceae, Porphyromonadaceae and Lachnospiraceae.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53871" y="482940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732525"/>
              </p:ext>
            </p:extLst>
          </p:nvPr>
        </p:nvGraphicFramePr>
        <p:xfrm>
          <a:off x="932879" y="5014067"/>
          <a:ext cx="484822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261126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23</TotalTime>
  <Words>116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egenga, Wilma</dc:creator>
  <cp:lastModifiedBy>Steegenga, Wilma</cp:lastModifiedBy>
  <cp:revision>485</cp:revision>
  <cp:lastPrinted>2015-09-09T07:19:58Z</cp:lastPrinted>
  <dcterms:created xsi:type="dcterms:W3CDTF">2013-09-10T04:43:47Z</dcterms:created>
  <dcterms:modified xsi:type="dcterms:W3CDTF">2016-03-25T07:27:58Z</dcterms:modified>
</cp:coreProperties>
</file>